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304" r:id="rId2"/>
    <p:sldId id="305" r:id="rId3"/>
    <p:sldId id="306" r:id="rId4"/>
  </p:sldIdLst>
  <p:sldSz cx="9144000" cy="8999538"/>
  <p:notesSz cx="6858000" cy="9144000"/>
  <p:custDataLst>
    <p:tags r:id="rId5"/>
  </p:custDataLst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3">
          <p15:clr>
            <a:srgbClr val="A4A3A4"/>
          </p15:clr>
        </p15:guide>
        <p15:guide id="2" pos="27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61" autoAdjust="0"/>
    <p:restoredTop sz="94531" autoAdjust="0"/>
  </p:normalViewPr>
  <p:slideViewPr>
    <p:cSldViewPr>
      <p:cViewPr varScale="1">
        <p:scale>
          <a:sx n="79" d="100"/>
          <a:sy n="79" d="100"/>
        </p:scale>
        <p:origin x="1856" y="216"/>
      </p:cViewPr>
      <p:guideLst>
        <p:guide orient="horz" pos="2893"/>
        <p:guide pos="27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E790F-4EF1-74F6-9E9A-8433E7313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6501C-4D5F-5162-395E-D6F3F11F3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9E1AE-4EB4-6433-33DE-BC7B4EE6B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B9865E-DDB8-B040-9F8C-DFE67195669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5412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6DC85B-E297-9821-E225-47349E06D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0A269-49CF-A57B-E472-D3F256212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5FC6F-D7A6-EC6D-42E4-1CBAEE79A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2D7FC-86B8-CF4B-8DC5-6B9D0EBE0F3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484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10EEA2-8200-9243-FADE-8F43D96AB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7A33F-04CD-65DC-7CE5-07138D651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AF56E-C1CD-BB3D-BB76-63F48741F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D2D767-1590-8A49-B67B-967B914D0B6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430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23851B-B66A-12FA-58D9-8492374B7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80104-3B83-FBF9-3708-82450D681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77989-6E41-E58B-C192-9C913647E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BDD794-C575-5E4E-BB96-5F8E654604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0817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EECB1-358A-D41E-ABF2-3AEBD33D4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0AEEAA-78B9-6084-B6F9-5E4CBDB9A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52E60-C256-70D5-91A3-9EB502C15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EA88FE-9FA3-334D-AEFA-DB411E14133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976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D7955A1-96F2-F248-E82A-3C3AA7D31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B958E63-0C6A-2CA2-3D4F-D50215361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6778608-5B38-E8B7-AA35-BC440BF71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52C507-1ADC-2F4D-8D07-1988263F34D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60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E5BF6F8-F52D-6A26-3C9D-72D26505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5518D6B3-6762-A08A-6FAD-D9E2BEC61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36F6141F-3F5F-F17B-5ECE-C52F5AF4D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AD3241-74D7-F64A-B598-69287180604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0867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687721AD-133C-1C96-C89C-4D6CE1EBB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73CF4646-371F-2E8D-D4A8-F4ADB2E4B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CC7EEDD1-38D2-5E6D-9039-7D82B809D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0ED0B-2919-2749-BD9F-972862910D4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92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E4FF3EC7-721C-A17D-8B55-A77BCD861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795EA250-5FFF-B8E9-4D1F-09F7C8099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D42933DD-229B-A4BE-45C3-AFF0CA48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518A03-55E3-A44A-A909-6AF3A19D0A6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39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324010B-BB6C-08C5-97B9-F77B896AE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87A6DBA-42E3-1BC7-AAAD-DB52F7201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185F0A8-A474-B9C9-F5BC-26C0E2343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7B6C3-FAD1-B247-B6BC-9B251083448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003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839453E-2058-85FF-EA1C-9414941FE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C783266-4FA5-E1AF-A8A1-3EA5D67E1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AA303638-2193-5BE2-D872-D3779CA79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370FA-A557-9945-BDED-8CACB631B60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339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199B8890-4D49-BDE8-44C7-2E7F9ADB9097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479425"/>
            <a:ext cx="7886700" cy="173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F30F0C39-3694-B110-B936-6C1DA5D5D79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2395538"/>
            <a:ext cx="7886700" cy="571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E59A0-C910-5E4B-A226-D0DE95766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AA3B1E-8587-517E-3C7D-DD19434321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8340725"/>
            <a:ext cx="30861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8A8A4-5015-CF6B-635A-8A23187811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F81981-DDFA-3049-9C9D-DB02B106842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1" name="图片 1">
            <a:extLst>
              <a:ext uri="{FF2B5EF4-FFF2-40B4-BE49-F238E27FC236}">
                <a16:creationId xmlns:a16="http://schemas.microsoft.com/office/drawing/2014/main" id="{17521C29-B2BF-B907-0592-E6410143F1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3" t="3883" r="4718"/>
          <a:stretch>
            <a:fillRect/>
          </a:stretch>
        </p:blipFill>
        <p:spPr bwMode="auto">
          <a:xfrm>
            <a:off x="2039938" y="2600325"/>
            <a:ext cx="5373687" cy="2944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22" name="文本框 30">
            <a:extLst>
              <a:ext uri="{FF2B5EF4-FFF2-40B4-BE49-F238E27FC236}">
                <a16:creationId xmlns:a16="http://schemas.microsoft.com/office/drawing/2014/main" id="{EE2ABECE-5851-4D2B-0C82-6DEFFD7A1E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Keap1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0723" name="文本框 18">
            <a:extLst>
              <a:ext uri="{FF2B5EF4-FFF2-40B4-BE49-F238E27FC236}">
                <a16:creationId xmlns:a16="http://schemas.microsoft.com/office/drawing/2014/main" id="{9040408C-7056-227A-FE1C-9D83ADA74F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3200" y="277495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0724" name="文本框 19">
            <a:extLst>
              <a:ext uri="{FF2B5EF4-FFF2-40B4-BE49-F238E27FC236}">
                <a16:creationId xmlns:a16="http://schemas.microsoft.com/office/drawing/2014/main" id="{5B630820-E3C9-8FF5-F11F-A27D6831B5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2973388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0725" name="文本框 20">
            <a:extLst>
              <a:ext uri="{FF2B5EF4-FFF2-40B4-BE49-F238E27FC236}">
                <a16:creationId xmlns:a16="http://schemas.microsoft.com/office/drawing/2014/main" id="{493D4206-175E-15BB-B2F0-295D64ACFB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3117850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0726" name="文本框 21">
            <a:extLst>
              <a:ext uri="{FF2B5EF4-FFF2-40B4-BE49-F238E27FC236}">
                <a16:creationId xmlns:a16="http://schemas.microsoft.com/office/drawing/2014/main" id="{513668AE-A78D-AB25-40E9-990D3A5AC7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325813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0727" name="文本框 22">
            <a:extLst>
              <a:ext uri="{FF2B5EF4-FFF2-40B4-BE49-F238E27FC236}">
                <a16:creationId xmlns:a16="http://schemas.microsoft.com/office/drawing/2014/main" id="{E46E577E-EAC4-2DB8-733A-CDCFC619DE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563938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0728" name="文本框 23">
            <a:extLst>
              <a:ext uri="{FF2B5EF4-FFF2-40B4-BE49-F238E27FC236}">
                <a16:creationId xmlns:a16="http://schemas.microsoft.com/office/drawing/2014/main" id="{170535BB-6EF0-BC8F-2F5A-AA13332031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91953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0729" name="文本框 24">
            <a:extLst>
              <a:ext uri="{FF2B5EF4-FFF2-40B4-BE49-F238E27FC236}">
                <a16:creationId xmlns:a16="http://schemas.microsoft.com/office/drawing/2014/main" id="{0FF00D0B-64FD-3D16-AF26-3EF1FD8E88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1910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0730" name="文本框 25">
            <a:extLst>
              <a:ext uri="{FF2B5EF4-FFF2-40B4-BE49-F238E27FC236}">
                <a16:creationId xmlns:a16="http://schemas.microsoft.com/office/drawing/2014/main" id="{138A2ACB-7E27-1768-5597-49BF99947E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4973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0731" name="文本框 26">
            <a:extLst>
              <a:ext uri="{FF2B5EF4-FFF2-40B4-BE49-F238E27FC236}">
                <a16:creationId xmlns:a16="http://schemas.microsoft.com/office/drawing/2014/main" id="{64F174E1-9CAC-6CFF-32AA-9E5FC21D5F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52197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CF175F5C-C83D-11D8-85AA-7360544D461A}"/>
              </a:ext>
            </a:extLst>
          </p:cNvPr>
          <p:cNvSpPr/>
          <p:nvPr/>
        </p:nvSpPr>
        <p:spPr>
          <a:xfrm>
            <a:off x="2635250" y="4141788"/>
            <a:ext cx="4068763" cy="33178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856F4331-67ED-4D5B-500C-2643E2261F23}"/>
              </a:ext>
            </a:extLst>
          </p:cNvPr>
          <p:cNvSpPr/>
          <p:nvPr/>
        </p:nvSpPr>
        <p:spPr>
          <a:xfrm>
            <a:off x="2592388" y="3348038"/>
            <a:ext cx="3959225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0734" name="文本框 56">
            <a:extLst>
              <a:ext uri="{FF2B5EF4-FFF2-40B4-BE49-F238E27FC236}">
                <a16:creationId xmlns:a16="http://schemas.microsoft.com/office/drawing/2014/main" id="{C72BFEA9-4664-0A4A-F1AE-9460099C15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5600" y="4564063"/>
            <a:ext cx="11557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0735" name="文本框 56">
            <a:extLst>
              <a:ext uri="{FF2B5EF4-FFF2-40B4-BE49-F238E27FC236}">
                <a16:creationId xmlns:a16="http://schemas.microsoft.com/office/drawing/2014/main" id="{C0C611C8-9449-201A-9F2C-4A44AB2717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925" y="2911475"/>
            <a:ext cx="11557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Keap1</a:t>
            </a:r>
          </a:p>
        </p:txBody>
      </p:sp>
      <p:sp>
        <p:nvSpPr>
          <p:cNvPr id="30736" name="文本框 3">
            <a:extLst>
              <a:ext uri="{FF2B5EF4-FFF2-40B4-BE49-F238E27FC236}">
                <a16:creationId xmlns:a16="http://schemas.microsoft.com/office/drawing/2014/main" id="{60EF117A-2746-9395-2D31-ED30C2BB6A4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694782" y="24074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0737" name="文本框 4">
            <a:extLst>
              <a:ext uri="{FF2B5EF4-FFF2-40B4-BE49-F238E27FC236}">
                <a16:creationId xmlns:a16="http://schemas.microsoft.com/office/drawing/2014/main" id="{07926A9E-63D7-8DAF-A4E0-B5147DB1E3B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07519" y="2356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0738" name="文本框 5">
            <a:extLst>
              <a:ext uri="{FF2B5EF4-FFF2-40B4-BE49-F238E27FC236}">
                <a16:creationId xmlns:a16="http://schemas.microsoft.com/office/drawing/2014/main" id="{70669BC0-3034-DBD8-3D6A-038023838F8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60737" y="2408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39" name="文本框 6">
            <a:extLst>
              <a:ext uri="{FF2B5EF4-FFF2-40B4-BE49-F238E27FC236}">
                <a16:creationId xmlns:a16="http://schemas.microsoft.com/office/drawing/2014/main" id="{02F382D2-69EE-EA66-4B9E-AEFB0386DA1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05225" y="2409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0" name="文本框 7">
            <a:extLst>
              <a:ext uri="{FF2B5EF4-FFF2-40B4-BE49-F238E27FC236}">
                <a16:creationId xmlns:a16="http://schemas.microsoft.com/office/drawing/2014/main" id="{8ADCF9EC-818F-84E3-E61E-960D6EB8DEC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69531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0741" name="文本框 8">
            <a:extLst>
              <a:ext uri="{FF2B5EF4-FFF2-40B4-BE49-F238E27FC236}">
                <a16:creationId xmlns:a16="http://schemas.microsoft.com/office/drawing/2014/main" id="{44BD790F-E613-7E33-E9E5-3E5E5C3C45E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10843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2" name="文本框 9">
            <a:extLst>
              <a:ext uri="{FF2B5EF4-FFF2-40B4-BE49-F238E27FC236}">
                <a16:creationId xmlns:a16="http://schemas.microsoft.com/office/drawing/2014/main" id="{94EE14E6-BA20-A89C-54D0-8D59706B859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33900" y="2112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3" name="文本框 10">
            <a:extLst>
              <a:ext uri="{FF2B5EF4-FFF2-40B4-BE49-F238E27FC236}">
                <a16:creationId xmlns:a16="http://schemas.microsoft.com/office/drawing/2014/main" id="{CB290768-37AE-8CBE-356D-017E6E2CD2F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33144" y="2099469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4" name="文本框 11">
            <a:extLst>
              <a:ext uri="{FF2B5EF4-FFF2-40B4-BE49-F238E27FC236}">
                <a16:creationId xmlns:a16="http://schemas.microsoft.com/office/drawing/2014/main" id="{D3196413-B906-31F9-AB95-24E3A2BCF31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5400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5" name="文本框 9">
            <a:extLst>
              <a:ext uri="{FF2B5EF4-FFF2-40B4-BE49-F238E27FC236}">
                <a16:creationId xmlns:a16="http://schemas.microsoft.com/office/drawing/2014/main" id="{FEFC916C-5B46-967E-5A50-2ADB6A76FEC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47506" y="2110582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6" name="文本框 10">
            <a:extLst>
              <a:ext uri="{FF2B5EF4-FFF2-40B4-BE49-F238E27FC236}">
                <a16:creationId xmlns:a16="http://schemas.microsoft.com/office/drawing/2014/main" id="{0011A167-653D-82DB-A947-C2AF2E27B9B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1513" y="2103437"/>
            <a:ext cx="1246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0747" name="文本框 11">
            <a:extLst>
              <a:ext uri="{FF2B5EF4-FFF2-40B4-BE49-F238E27FC236}">
                <a16:creationId xmlns:a16="http://schemas.microsoft.com/office/drawing/2014/main" id="{510CAF15-62E1-25CB-4C4C-1F8E002CB35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94413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5" name="图片 3" descr="NLRP3">
            <a:extLst>
              <a:ext uri="{FF2B5EF4-FFF2-40B4-BE49-F238E27FC236}">
                <a16:creationId xmlns:a16="http://schemas.microsoft.com/office/drawing/2014/main" id="{E3EDF683-CE65-E941-61F4-DD6DBC5561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69" t="4358"/>
          <a:stretch>
            <a:fillRect/>
          </a:stretch>
        </p:blipFill>
        <p:spPr bwMode="auto">
          <a:xfrm>
            <a:off x="2195513" y="2776538"/>
            <a:ext cx="4787900" cy="3246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746" name="文本框 30">
            <a:extLst>
              <a:ext uri="{FF2B5EF4-FFF2-40B4-BE49-F238E27FC236}">
                <a16:creationId xmlns:a16="http://schemas.microsoft.com/office/drawing/2014/main" id="{E17E7B96-E0CE-FDB5-840D-1170A9720C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Nox4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1747" name="文本框 18">
            <a:extLst>
              <a:ext uri="{FF2B5EF4-FFF2-40B4-BE49-F238E27FC236}">
                <a16:creationId xmlns:a16="http://schemas.microsoft.com/office/drawing/2014/main" id="{7F0206B7-77CD-E4F7-FFB7-718A070FB9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3200" y="277495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1748" name="文本框 19">
            <a:extLst>
              <a:ext uri="{FF2B5EF4-FFF2-40B4-BE49-F238E27FC236}">
                <a16:creationId xmlns:a16="http://schemas.microsoft.com/office/drawing/2014/main" id="{6E9A7871-41F8-4F82-86AE-5DA305619B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2973388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1749" name="文本框 20">
            <a:extLst>
              <a:ext uri="{FF2B5EF4-FFF2-40B4-BE49-F238E27FC236}">
                <a16:creationId xmlns:a16="http://schemas.microsoft.com/office/drawing/2014/main" id="{17008256-78A8-0347-3137-B132E6D425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3117850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1750" name="文本框 21">
            <a:extLst>
              <a:ext uri="{FF2B5EF4-FFF2-40B4-BE49-F238E27FC236}">
                <a16:creationId xmlns:a16="http://schemas.microsoft.com/office/drawing/2014/main" id="{FDEEB7B1-5D49-469C-7981-168F87AEA6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325813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1751" name="文本框 22">
            <a:extLst>
              <a:ext uri="{FF2B5EF4-FFF2-40B4-BE49-F238E27FC236}">
                <a16:creationId xmlns:a16="http://schemas.microsoft.com/office/drawing/2014/main" id="{A583F845-3943-51E5-3561-E6FCC65807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563938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1752" name="文本框 23">
            <a:extLst>
              <a:ext uri="{FF2B5EF4-FFF2-40B4-BE49-F238E27FC236}">
                <a16:creationId xmlns:a16="http://schemas.microsoft.com/office/drawing/2014/main" id="{5E3A93FC-D49C-8971-72CB-BF86DF8117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91953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1753" name="文本框 24">
            <a:extLst>
              <a:ext uri="{FF2B5EF4-FFF2-40B4-BE49-F238E27FC236}">
                <a16:creationId xmlns:a16="http://schemas.microsoft.com/office/drawing/2014/main" id="{A155BA41-8CB6-57A1-7EDC-B5E6398A89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1910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1754" name="文本框 25">
            <a:extLst>
              <a:ext uri="{FF2B5EF4-FFF2-40B4-BE49-F238E27FC236}">
                <a16:creationId xmlns:a16="http://schemas.microsoft.com/office/drawing/2014/main" id="{1F4AF41F-63FE-286F-46FD-B9C8922FD9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4973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1755" name="文本框 26">
            <a:extLst>
              <a:ext uri="{FF2B5EF4-FFF2-40B4-BE49-F238E27FC236}">
                <a16:creationId xmlns:a16="http://schemas.microsoft.com/office/drawing/2014/main" id="{420E80D6-F03E-25D9-FDA2-2EC0F4450C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52197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05B4CC47-6748-9F42-588C-FD190B0C5F9E}"/>
              </a:ext>
            </a:extLst>
          </p:cNvPr>
          <p:cNvSpPr/>
          <p:nvPr/>
        </p:nvSpPr>
        <p:spPr>
          <a:xfrm>
            <a:off x="2635250" y="4141788"/>
            <a:ext cx="4068763" cy="33178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B9C67E5E-75AA-0F8D-ED35-878F5C985491}"/>
              </a:ext>
            </a:extLst>
          </p:cNvPr>
          <p:cNvSpPr/>
          <p:nvPr/>
        </p:nvSpPr>
        <p:spPr>
          <a:xfrm>
            <a:off x="2700338" y="2987675"/>
            <a:ext cx="3959225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1758" name="文本框 56">
            <a:extLst>
              <a:ext uri="{FF2B5EF4-FFF2-40B4-BE49-F238E27FC236}">
                <a16:creationId xmlns:a16="http://schemas.microsoft.com/office/drawing/2014/main" id="{7193660A-DD16-3877-2404-2555306728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5600" y="4564063"/>
            <a:ext cx="11557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1759" name="文本框 56">
            <a:extLst>
              <a:ext uri="{FF2B5EF4-FFF2-40B4-BE49-F238E27FC236}">
                <a16:creationId xmlns:a16="http://schemas.microsoft.com/office/drawing/2014/main" id="{2EECD249-F857-CB19-9655-EBA3D25766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0063" y="2692400"/>
            <a:ext cx="11557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NLRP3</a:t>
            </a:r>
          </a:p>
        </p:txBody>
      </p:sp>
      <p:sp>
        <p:nvSpPr>
          <p:cNvPr id="31760" name="文本框 3">
            <a:extLst>
              <a:ext uri="{FF2B5EF4-FFF2-40B4-BE49-F238E27FC236}">
                <a16:creationId xmlns:a16="http://schemas.microsoft.com/office/drawing/2014/main" id="{09B0C532-1ECE-3300-5858-EDB6238FB9E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694782" y="24074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1761" name="文本框 4">
            <a:extLst>
              <a:ext uri="{FF2B5EF4-FFF2-40B4-BE49-F238E27FC236}">
                <a16:creationId xmlns:a16="http://schemas.microsoft.com/office/drawing/2014/main" id="{DC05CB09-A408-6BBB-F23C-EC205452B62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07519" y="2356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1762" name="文本框 5">
            <a:extLst>
              <a:ext uri="{FF2B5EF4-FFF2-40B4-BE49-F238E27FC236}">
                <a16:creationId xmlns:a16="http://schemas.microsoft.com/office/drawing/2014/main" id="{7E5F9A14-19FC-836F-E0C9-6ED582630C6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60737" y="2408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3" name="文本框 6">
            <a:extLst>
              <a:ext uri="{FF2B5EF4-FFF2-40B4-BE49-F238E27FC236}">
                <a16:creationId xmlns:a16="http://schemas.microsoft.com/office/drawing/2014/main" id="{83330EF8-779D-47BD-E783-615D984EC1C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05225" y="2409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4" name="文本框 7">
            <a:extLst>
              <a:ext uri="{FF2B5EF4-FFF2-40B4-BE49-F238E27FC236}">
                <a16:creationId xmlns:a16="http://schemas.microsoft.com/office/drawing/2014/main" id="{D865002D-C5FE-9E51-7C17-4FFE8093811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69531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1765" name="文本框 8">
            <a:extLst>
              <a:ext uri="{FF2B5EF4-FFF2-40B4-BE49-F238E27FC236}">
                <a16:creationId xmlns:a16="http://schemas.microsoft.com/office/drawing/2014/main" id="{BDFD0D62-DCBD-ED72-0A29-92B0EAE325C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10843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6" name="文本框 9">
            <a:extLst>
              <a:ext uri="{FF2B5EF4-FFF2-40B4-BE49-F238E27FC236}">
                <a16:creationId xmlns:a16="http://schemas.microsoft.com/office/drawing/2014/main" id="{9FC54805-20D9-09CE-684B-732741A8F85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33900" y="2112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7" name="文本框 10">
            <a:extLst>
              <a:ext uri="{FF2B5EF4-FFF2-40B4-BE49-F238E27FC236}">
                <a16:creationId xmlns:a16="http://schemas.microsoft.com/office/drawing/2014/main" id="{602B1ADA-8E46-6C5B-2C14-2EA524345D4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33144" y="2099469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8" name="文本框 11">
            <a:extLst>
              <a:ext uri="{FF2B5EF4-FFF2-40B4-BE49-F238E27FC236}">
                <a16:creationId xmlns:a16="http://schemas.microsoft.com/office/drawing/2014/main" id="{8355BEB7-6E0E-CE13-C87D-C66AE1367D2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5400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69" name="文本框 9">
            <a:extLst>
              <a:ext uri="{FF2B5EF4-FFF2-40B4-BE49-F238E27FC236}">
                <a16:creationId xmlns:a16="http://schemas.microsoft.com/office/drawing/2014/main" id="{52F488C3-94B5-3F23-1717-10D5B3957A9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47506" y="2110582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70" name="文本框 10">
            <a:extLst>
              <a:ext uri="{FF2B5EF4-FFF2-40B4-BE49-F238E27FC236}">
                <a16:creationId xmlns:a16="http://schemas.microsoft.com/office/drawing/2014/main" id="{A55CEC91-DC16-EC73-A8B8-811E51E3358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1513" y="2103437"/>
            <a:ext cx="1246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1771" name="文本框 11">
            <a:extLst>
              <a:ext uri="{FF2B5EF4-FFF2-40B4-BE49-F238E27FC236}">
                <a16:creationId xmlns:a16="http://schemas.microsoft.com/office/drawing/2014/main" id="{AA545660-2048-0BC8-A95D-C0CE25CBE36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94413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69" name="图片 1">
            <a:extLst>
              <a:ext uri="{FF2B5EF4-FFF2-40B4-BE49-F238E27FC236}">
                <a16:creationId xmlns:a16="http://schemas.microsoft.com/office/drawing/2014/main" id="{AE9E61B8-5509-ABDC-2F40-D5F55CA642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7" t="5753"/>
          <a:stretch>
            <a:fillRect/>
          </a:stretch>
        </p:blipFill>
        <p:spPr bwMode="auto">
          <a:xfrm>
            <a:off x="2192338" y="2641600"/>
            <a:ext cx="5203825" cy="3276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770" name="文本框 30">
            <a:extLst>
              <a:ext uri="{FF2B5EF4-FFF2-40B4-BE49-F238E27FC236}">
                <a16:creationId xmlns:a16="http://schemas.microsoft.com/office/drawing/2014/main" id="{091D90E0-D52B-AA0A-5E57-2EE6F7B4E2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Nrf2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2771" name="文本框 18">
            <a:extLst>
              <a:ext uri="{FF2B5EF4-FFF2-40B4-BE49-F238E27FC236}">
                <a16:creationId xmlns:a16="http://schemas.microsoft.com/office/drawing/2014/main" id="{91C6F34F-9253-4FC5-AB89-1C7985BF94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3200" y="277495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2772" name="文本框 19">
            <a:extLst>
              <a:ext uri="{FF2B5EF4-FFF2-40B4-BE49-F238E27FC236}">
                <a16:creationId xmlns:a16="http://schemas.microsoft.com/office/drawing/2014/main" id="{4F24266B-F23A-FE94-0921-1309D946C8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2973388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2773" name="文本框 20">
            <a:extLst>
              <a:ext uri="{FF2B5EF4-FFF2-40B4-BE49-F238E27FC236}">
                <a16:creationId xmlns:a16="http://schemas.microsoft.com/office/drawing/2014/main" id="{7A8EFD86-7D9C-707E-E957-43765EFC83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3117850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2774" name="文本框 21">
            <a:extLst>
              <a:ext uri="{FF2B5EF4-FFF2-40B4-BE49-F238E27FC236}">
                <a16:creationId xmlns:a16="http://schemas.microsoft.com/office/drawing/2014/main" id="{03D7D6C2-4E1D-A730-0D2A-8C30C45C2E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325813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2775" name="文本框 22">
            <a:extLst>
              <a:ext uri="{FF2B5EF4-FFF2-40B4-BE49-F238E27FC236}">
                <a16:creationId xmlns:a16="http://schemas.microsoft.com/office/drawing/2014/main" id="{F4E48763-8B72-CB8B-1228-82D964F53B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563938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2776" name="文本框 23">
            <a:extLst>
              <a:ext uri="{FF2B5EF4-FFF2-40B4-BE49-F238E27FC236}">
                <a16:creationId xmlns:a16="http://schemas.microsoft.com/office/drawing/2014/main" id="{B1B5D737-3E0E-26CA-2A3D-244A535D8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91953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2777" name="文本框 24">
            <a:extLst>
              <a:ext uri="{FF2B5EF4-FFF2-40B4-BE49-F238E27FC236}">
                <a16:creationId xmlns:a16="http://schemas.microsoft.com/office/drawing/2014/main" id="{D5AA05F5-124F-A5C9-8E2B-D16BFD64DC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1910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2778" name="文本框 25">
            <a:extLst>
              <a:ext uri="{FF2B5EF4-FFF2-40B4-BE49-F238E27FC236}">
                <a16:creationId xmlns:a16="http://schemas.microsoft.com/office/drawing/2014/main" id="{2033061A-F5D5-D925-1F7B-9F4B85D151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4973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2779" name="文本框 26">
            <a:extLst>
              <a:ext uri="{FF2B5EF4-FFF2-40B4-BE49-F238E27FC236}">
                <a16:creationId xmlns:a16="http://schemas.microsoft.com/office/drawing/2014/main" id="{D5BF6A2D-AFD6-56F7-4030-65EA00AF0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52197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A26561F9-9F55-54F8-FB36-B4614256ACBE}"/>
              </a:ext>
            </a:extLst>
          </p:cNvPr>
          <p:cNvSpPr/>
          <p:nvPr/>
        </p:nvSpPr>
        <p:spPr>
          <a:xfrm>
            <a:off x="2652713" y="4225925"/>
            <a:ext cx="4068762" cy="3317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ABCBDC01-6C8E-7DEF-6D69-B5FFEEA894E6}"/>
              </a:ext>
            </a:extLst>
          </p:cNvPr>
          <p:cNvSpPr/>
          <p:nvPr/>
        </p:nvSpPr>
        <p:spPr>
          <a:xfrm>
            <a:off x="2847975" y="3503613"/>
            <a:ext cx="3959225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2782" name="文本框 56">
            <a:extLst>
              <a:ext uri="{FF2B5EF4-FFF2-40B4-BE49-F238E27FC236}">
                <a16:creationId xmlns:a16="http://schemas.microsoft.com/office/drawing/2014/main" id="{B45E1660-9E9C-DEBE-1DE1-449327BA3F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5600" y="4564063"/>
            <a:ext cx="11557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2783" name="文本框 56">
            <a:extLst>
              <a:ext uri="{FF2B5EF4-FFF2-40B4-BE49-F238E27FC236}">
                <a16:creationId xmlns:a16="http://schemas.microsoft.com/office/drawing/2014/main" id="{61661140-6376-46A1-D6AC-8EA19C5138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8375" y="3062288"/>
            <a:ext cx="11557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Nox4</a:t>
            </a:r>
          </a:p>
        </p:txBody>
      </p:sp>
      <p:sp>
        <p:nvSpPr>
          <p:cNvPr id="32784" name="文本框 3">
            <a:extLst>
              <a:ext uri="{FF2B5EF4-FFF2-40B4-BE49-F238E27FC236}">
                <a16:creationId xmlns:a16="http://schemas.microsoft.com/office/drawing/2014/main" id="{D3636DAD-81FF-1FB8-0D47-D95ED94818A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694782" y="24074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2785" name="文本框 4">
            <a:extLst>
              <a:ext uri="{FF2B5EF4-FFF2-40B4-BE49-F238E27FC236}">
                <a16:creationId xmlns:a16="http://schemas.microsoft.com/office/drawing/2014/main" id="{179B9D40-1EF2-583B-1967-336D9E5BD1A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07519" y="2356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2786" name="文本框 5">
            <a:extLst>
              <a:ext uri="{FF2B5EF4-FFF2-40B4-BE49-F238E27FC236}">
                <a16:creationId xmlns:a16="http://schemas.microsoft.com/office/drawing/2014/main" id="{6ECB4962-783F-79BB-FE10-AAAE00642A6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60737" y="2408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87" name="文本框 6">
            <a:extLst>
              <a:ext uri="{FF2B5EF4-FFF2-40B4-BE49-F238E27FC236}">
                <a16:creationId xmlns:a16="http://schemas.microsoft.com/office/drawing/2014/main" id="{0EC567DE-E815-716F-1D34-E72B040E93D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05225" y="2409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88" name="文本框 7">
            <a:extLst>
              <a:ext uri="{FF2B5EF4-FFF2-40B4-BE49-F238E27FC236}">
                <a16:creationId xmlns:a16="http://schemas.microsoft.com/office/drawing/2014/main" id="{0AED1757-B1DF-05DD-1E01-B9032367E11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69531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2789" name="文本框 8">
            <a:extLst>
              <a:ext uri="{FF2B5EF4-FFF2-40B4-BE49-F238E27FC236}">
                <a16:creationId xmlns:a16="http://schemas.microsoft.com/office/drawing/2014/main" id="{264199EA-00E8-17F0-2565-C4D1E90A676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10843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0" name="文本框 9">
            <a:extLst>
              <a:ext uri="{FF2B5EF4-FFF2-40B4-BE49-F238E27FC236}">
                <a16:creationId xmlns:a16="http://schemas.microsoft.com/office/drawing/2014/main" id="{820F4518-E21E-DF93-478C-651F8F52935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33900" y="2112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1" name="文本框 10">
            <a:extLst>
              <a:ext uri="{FF2B5EF4-FFF2-40B4-BE49-F238E27FC236}">
                <a16:creationId xmlns:a16="http://schemas.microsoft.com/office/drawing/2014/main" id="{11C34973-9618-FC98-AB5A-87E76F9AABF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33144" y="2099469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2" name="文本框 11">
            <a:extLst>
              <a:ext uri="{FF2B5EF4-FFF2-40B4-BE49-F238E27FC236}">
                <a16:creationId xmlns:a16="http://schemas.microsoft.com/office/drawing/2014/main" id="{6DE4F91C-7E93-BCC0-2F46-9888A234EAD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5400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3" name="文本框 9">
            <a:extLst>
              <a:ext uri="{FF2B5EF4-FFF2-40B4-BE49-F238E27FC236}">
                <a16:creationId xmlns:a16="http://schemas.microsoft.com/office/drawing/2014/main" id="{A3BED64C-14E4-7AA3-7E4F-88EFD41DCA4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47506" y="2110582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4" name="文本框 10">
            <a:extLst>
              <a:ext uri="{FF2B5EF4-FFF2-40B4-BE49-F238E27FC236}">
                <a16:creationId xmlns:a16="http://schemas.microsoft.com/office/drawing/2014/main" id="{66CF55E2-035E-8F62-8661-5B128EAA87B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1513" y="2103437"/>
            <a:ext cx="1246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32795" name="文本框 11">
            <a:extLst>
              <a:ext uri="{FF2B5EF4-FFF2-40B4-BE49-F238E27FC236}">
                <a16:creationId xmlns:a16="http://schemas.microsoft.com/office/drawing/2014/main" id="{830B8FFD-168B-90B1-C272-6402FABD6C3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94413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TU2ZjdiN2JjZTY4ZGM3YWFmYzRjMTJiMDJlMzdkOD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9</TotalTime>
  <Words>126</Words>
  <Application>Microsoft Macintosh PowerPoint</Application>
  <PresentationFormat>自定义</PresentationFormat>
  <Paragraphs>7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cp:lastModifiedBy>18942356872@163.com</cp:lastModifiedBy>
  <cp:revision>80</cp:revision>
  <dcterms:created xsi:type="dcterms:W3CDTF">2024-12-08T09:18:18Z</dcterms:created>
  <dcterms:modified xsi:type="dcterms:W3CDTF">2025-12-20T10:16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321CCEA3293149FF97CD9B16CFEB8259_12</vt:lpwstr>
  </property>
</Properties>
</file>